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324" y="21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921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808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02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419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294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307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759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80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664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579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996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5B702-7122-4C94-882C-83644EAEC30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06F14-F45A-4704-89C9-59712B1DB2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744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5800" y="649069"/>
            <a:ext cx="762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Appendix: Full length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T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equences of different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ssica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14" r="9335" b="13342"/>
          <a:stretch/>
        </p:blipFill>
        <p:spPr bwMode="auto">
          <a:xfrm>
            <a:off x="0" y="1757082"/>
            <a:ext cx="9122168" cy="45675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457200" y="1940860"/>
            <a:ext cx="8113060" cy="13357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259965" y="3464860"/>
            <a:ext cx="8319260" cy="13357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64460" y="5029200"/>
            <a:ext cx="8319260" cy="13357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68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40" r="9197" b="11352"/>
          <a:stretch/>
        </p:blipFill>
        <p:spPr bwMode="auto">
          <a:xfrm>
            <a:off x="0" y="829435"/>
            <a:ext cx="9144000" cy="4580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268930" y="999565"/>
            <a:ext cx="8319260" cy="13357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224105" y="2550460"/>
            <a:ext cx="4083435" cy="133574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307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07" r="9021" b="11123"/>
          <a:stretch/>
        </p:blipFill>
        <p:spPr bwMode="auto">
          <a:xfrm>
            <a:off x="0" y="990600"/>
            <a:ext cx="9144000" cy="45810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62974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1143000"/>
            <a:ext cx="9144000" cy="4755466"/>
            <a:chOff x="0" y="1143000"/>
            <a:chExt cx="9144000" cy="4755466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78" r="8993" b="11660"/>
            <a:stretch/>
          </p:blipFill>
          <p:spPr bwMode="auto">
            <a:xfrm>
              <a:off x="0" y="1143000"/>
              <a:ext cx="9144000" cy="45452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4572000" y="5561479"/>
              <a:ext cx="2133600" cy="12682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078002" y="5652245"/>
              <a:ext cx="8675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TamiR38</a:t>
              </a:r>
              <a:endParaRPr lang="en-US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50700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990600"/>
            <a:ext cx="9144000" cy="4594845"/>
            <a:chOff x="0" y="990600"/>
            <a:chExt cx="9144000" cy="4594845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497" r="9149" b="11304"/>
            <a:stretch/>
          </p:blipFill>
          <p:spPr bwMode="auto">
            <a:xfrm>
              <a:off x="0" y="990600"/>
              <a:ext cx="9144000" cy="45948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6768355" y="2348755"/>
              <a:ext cx="1766045" cy="1143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277905" y="3892925"/>
              <a:ext cx="331695" cy="11430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247462" y="2407334"/>
              <a:ext cx="8675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TamiR40</a:t>
              </a:r>
              <a:endParaRPr lang="en-US" sz="10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3247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8965" y="152400"/>
            <a:ext cx="9152965" cy="6140707"/>
            <a:chOff x="-8965" y="152400"/>
            <a:chExt cx="9152965" cy="6140707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" t="7805" r="8861" b="11086"/>
            <a:stretch/>
          </p:blipFill>
          <p:spPr bwMode="auto">
            <a:xfrm>
              <a:off x="0" y="152400"/>
              <a:ext cx="9144000" cy="45847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4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8486" r="8694" b="15405"/>
            <a:stretch/>
          </p:blipFill>
          <p:spPr bwMode="auto">
            <a:xfrm>
              <a:off x="-8965" y="4823011"/>
              <a:ext cx="9144000" cy="14700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998405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90600" y="1143000"/>
            <a:ext cx="7086600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3g21560, 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GT full length gene from TAIR database  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pa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rugt84A9b and Brugt84A9d)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eracea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ougt84A9a and Bougt84A9c),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nugt84A9a, Bnugt84A9b, Bnugt84A9c and Bnugt84A9d)  paralogues obtained from EMBL database 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jSGT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isolated from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uncea</a:t>
            </a:r>
            <a:endParaRPr lang="en-US" sz="14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morphic regions are shown in black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xes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ull length gene sequenc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for the development of antisense constructs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s which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 in red boxe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for development of RNAi constructs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s which are shown in green boxe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as artificial microRNA target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65310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</TotalTime>
  <Words>118</Words>
  <Application>Microsoft Office PowerPoint</Application>
  <PresentationFormat>On-screen Show (4:3)</PresentationFormat>
  <Paragraphs>16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Sachin Kajla</cp:lastModifiedBy>
  <cp:revision>15</cp:revision>
  <dcterms:created xsi:type="dcterms:W3CDTF">2017-05-03T05:46:39Z</dcterms:created>
  <dcterms:modified xsi:type="dcterms:W3CDTF">2017-05-08T11:46:07Z</dcterms:modified>
</cp:coreProperties>
</file>